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9" d="100"/>
          <a:sy n="119" d="100"/>
        </p:scale>
        <p:origin x="138" y="11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10/2017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GB" sz="3200" dirty="0">
                <a:solidFill>
                  <a:srgbClr val="1F4E79"/>
                </a:solidFill>
                <a:latin typeface="Cambria" panose="020405030504060302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Dual time point FDG PET/CT imaging in prosthetic heart valve endocarditis</a:t>
            </a:r>
            <a:endParaRPr lang="en-US" altLang="en-US" sz="3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noFill/>
            <a:miter lim="800000"/>
            <a:headEnd/>
            <a:tailEnd/>
          </a:ln>
        </p:spPr>
        <p:txBody>
          <a:bodyPr anchor="t"/>
          <a:lstStyle/>
          <a:p>
            <a:pPr>
              <a:spcAft>
                <a:spcPts val="0"/>
              </a:spcAft>
            </a:pP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AM Scholtens</a:t>
            </a:r>
            <a:r>
              <a:rPr lang="en-GB" sz="1600" baseline="30000" dirty="0"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, LE Swart</a:t>
            </a:r>
            <a:r>
              <a:rPr lang="en-GB" sz="1600" baseline="30000" dirty="0"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, HJ Verberne</a:t>
            </a:r>
            <a:r>
              <a:rPr lang="en-GB" sz="1600" baseline="30000" dirty="0"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, RPJ Budde</a:t>
            </a:r>
            <a:r>
              <a:rPr lang="en-GB" sz="1600" baseline="30000" dirty="0"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, MGEH Lam</a:t>
            </a:r>
            <a:r>
              <a:rPr lang="en-GB" sz="1600" baseline="30000" dirty="0"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GB" sz="1600" dirty="0">
              <a:ea typeface="Times New Roman" panose="02020603050405020304" pitchFamily="18" charset="0"/>
            </a:endParaRPr>
          </a:p>
          <a:p>
            <a:r>
              <a:rPr lang="en-GB" sz="1100" baseline="30000" dirty="0"/>
              <a:t>1</a:t>
            </a:r>
            <a:r>
              <a:rPr lang="en-GB" sz="1100" dirty="0"/>
              <a:t>: Meander Medical </a:t>
            </a:r>
            <a:r>
              <a:rPr lang="en-GB" sz="1100" dirty="0" err="1"/>
              <a:t>Center</a:t>
            </a:r>
            <a:r>
              <a:rPr lang="en-GB" sz="1100" dirty="0"/>
              <a:t>, Amersfoort, the Netherlands	</a:t>
            </a:r>
          </a:p>
          <a:p>
            <a:r>
              <a:rPr lang="en-GB" sz="1100" baseline="30000" dirty="0"/>
              <a:t>2</a:t>
            </a:r>
            <a:r>
              <a:rPr lang="en-GB" sz="1100" dirty="0"/>
              <a:t>: Erasmus Medical </a:t>
            </a:r>
            <a:r>
              <a:rPr lang="en-GB" sz="1100" dirty="0" err="1"/>
              <a:t>Center</a:t>
            </a:r>
            <a:r>
              <a:rPr lang="en-GB" sz="1100" dirty="0"/>
              <a:t>, Rotterdam, the Netherlands	</a:t>
            </a:r>
          </a:p>
          <a:p>
            <a:r>
              <a:rPr lang="en-GB" sz="1100" baseline="30000" dirty="0"/>
              <a:t>3</a:t>
            </a:r>
            <a:r>
              <a:rPr lang="en-GB" sz="1100" dirty="0"/>
              <a:t>: Academic Medical </a:t>
            </a:r>
            <a:r>
              <a:rPr lang="en-GB" sz="1100" dirty="0" err="1"/>
              <a:t>Center</a:t>
            </a:r>
            <a:r>
              <a:rPr lang="en-GB" sz="1100" dirty="0"/>
              <a:t>, Amsterdam, the Netherlands	</a:t>
            </a:r>
          </a:p>
          <a:p>
            <a:r>
              <a:rPr lang="en-GB" sz="1100" baseline="30000" dirty="0"/>
              <a:t>4</a:t>
            </a:r>
            <a:r>
              <a:rPr lang="en-GB" sz="1100" dirty="0"/>
              <a:t>: University Medical </a:t>
            </a:r>
            <a:r>
              <a:rPr lang="en-GB" sz="1100" dirty="0" err="1"/>
              <a:t>Center</a:t>
            </a:r>
            <a:r>
              <a:rPr lang="en-GB" sz="1100" dirty="0"/>
              <a:t> Utrecht, the Netherlands	</a:t>
            </a:r>
          </a:p>
          <a:p>
            <a:endParaRPr lang="en-US" altLang="en-US" sz="16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Afbeelding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17936" y="3886200"/>
            <a:ext cx="2535464" cy="15240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5617936" y="3879706"/>
            <a:ext cx="2535464" cy="1524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6" name="Afbeelding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0424" y="3879706"/>
            <a:ext cx="1030398" cy="153049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1224277" y="3879706"/>
            <a:ext cx="1026545" cy="1524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800" dirty="0"/>
              <a:t>1-	</a:t>
            </a:r>
            <a:r>
              <a:rPr lang="en-US" sz="2400" dirty="0"/>
              <a:t>FDG PET/CT </a:t>
            </a:r>
            <a:r>
              <a:rPr lang="en-GB" sz="2400" dirty="0"/>
              <a:t>has been of increasing interest in 	prosthetic heart valve endocarditis (PVE)</a:t>
            </a:r>
            <a:r>
              <a:rPr lang="en-US" altLang="en-US" sz="2400" dirty="0"/>
              <a:t> 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800" dirty="0"/>
              <a:t>2- 	</a:t>
            </a:r>
            <a:r>
              <a:rPr lang="en-US" altLang="en-US" sz="2400" dirty="0"/>
              <a:t>The optimal imaging protocol for FDG PET/CT in 	PVE is still unclear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800" dirty="0"/>
              <a:t>3-	</a:t>
            </a:r>
            <a:r>
              <a:rPr lang="en-US" altLang="en-US" sz="2400" dirty="0"/>
              <a:t>Some (case) reports advocate later imaging time 	points to improve diagnostic accurac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i="1" dirty="0"/>
              <a:t>Study type</a:t>
            </a:r>
            <a:r>
              <a:rPr lang="en-US" altLang="en-US" sz="2800" dirty="0"/>
              <a:t>:</a:t>
            </a:r>
            <a:endParaRPr lang="en-US" altLang="en-US" sz="2400" dirty="0"/>
          </a:p>
          <a:p>
            <a:pPr marL="400050" lvl="1" indent="0">
              <a:buNone/>
            </a:pPr>
            <a:r>
              <a:rPr lang="en-US" altLang="en-US" sz="2400" dirty="0"/>
              <a:t>Retrospective observational case control cohort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i="1" dirty="0"/>
              <a:t>Study subjects</a:t>
            </a:r>
            <a:r>
              <a:rPr lang="en-US" altLang="en-US" sz="2800" dirty="0"/>
              <a:t>: </a:t>
            </a:r>
          </a:p>
          <a:p>
            <a:pPr marL="400050" lvl="1" indent="0">
              <a:buNone/>
            </a:pPr>
            <a:r>
              <a:rPr lang="en-GB" sz="2400" dirty="0"/>
              <a:t>Patients referred for FDG PET/CT for suspicion of PVE 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i="1" dirty="0"/>
              <a:t>Study endpoint</a:t>
            </a:r>
            <a:r>
              <a:rPr lang="en-US" altLang="en-US" sz="2800" dirty="0"/>
              <a:t>:</a:t>
            </a:r>
          </a:p>
          <a:p>
            <a:pPr marL="400050" lvl="1" indent="0">
              <a:buNone/>
            </a:pPr>
            <a:r>
              <a:rPr lang="en-GB" sz="2400" dirty="0"/>
              <a:t>PVE based on surgical findings in all cases and on unremarkable follow up in all controls.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i="1" dirty="0"/>
              <a:t>Study variables</a:t>
            </a:r>
            <a:r>
              <a:rPr lang="en-US" altLang="en-US" sz="2800" dirty="0"/>
              <a:t>:</a:t>
            </a:r>
          </a:p>
          <a:p>
            <a:pPr marL="400050" lvl="1" indent="0">
              <a:buNone/>
            </a:pPr>
            <a:r>
              <a:rPr lang="en-US" altLang="en-US" sz="2400" dirty="0"/>
              <a:t>Visual analysis, </a:t>
            </a:r>
            <a:r>
              <a:rPr lang="en-US" altLang="en-US" sz="2400" dirty="0" err="1"/>
              <a:t>SUVmax</a:t>
            </a:r>
            <a:r>
              <a:rPr lang="en-US" altLang="en-US" sz="2400" dirty="0"/>
              <a:t> and Target-to-background ratio (TBR) at standard (60min) and late (150min) time point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12" name="Tabel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5388291"/>
              </p:ext>
            </p:extLst>
          </p:nvPr>
        </p:nvGraphicFramePr>
        <p:xfrm>
          <a:off x="457196" y="1657985"/>
          <a:ext cx="8229604" cy="4352704"/>
        </p:xfrm>
        <a:graphic>
          <a:graphicData uri="http://schemas.openxmlformats.org/drawingml/2006/table">
            <a:tbl>
              <a:tblPr firstRow="1" firstCol="1" bandRow="1"/>
              <a:tblGrid>
                <a:gridCol w="624048">
                  <a:extLst>
                    <a:ext uri="{9D8B030D-6E8A-4147-A177-3AD203B41FA5}">
                      <a16:colId xmlns:a16="http://schemas.microsoft.com/office/drawing/2014/main" val="1440822370"/>
                    </a:ext>
                  </a:extLst>
                </a:gridCol>
                <a:gridCol w="346414">
                  <a:extLst>
                    <a:ext uri="{9D8B030D-6E8A-4147-A177-3AD203B41FA5}">
                      <a16:colId xmlns:a16="http://schemas.microsoft.com/office/drawing/2014/main" val="3416369864"/>
                    </a:ext>
                  </a:extLst>
                </a:gridCol>
                <a:gridCol w="624048">
                  <a:extLst>
                    <a:ext uri="{9D8B030D-6E8A-4147-A177-3AD203B41FA5}">
                      <a16:colId xmlns:a16="http://schemas.microsoft.com/office/drawing/2014/main" val="3429430047"/>
                    </a:ext>
                  </a:extLst>
                </a:gridCol>
                <a:gridCol w="499540">
                  <a:extLst>
                    <a:ext uri="{9D8B030D-6E8A-4147-A177-3AD203B41FA5}">
                      <a16:colId xmlns:a16="http://schemas.microsoft.com/office/drawing/2014/main" val="3084061226"/>
                    </a:ext>
                  </a:extLst>
                </a:gridCol>
                <a:gridCol w="605472">
                  <a:extLst>
                    <a:ext uri="{9D8B030D-6E8A-4147-A177-3AD203B41FA5}">
                      <a16:colId xmlns:a16="http://schemas.microsoft.com/office/drawing/2014/main" val="4010344277"/>
                    </a:ext>
                  </a:extLst>
                </a:gridCol>
                <a:gridCol w="1390176">
                  <a:extLst>
                    <a:ext uri="{9D8B030D-6E8A-4147-A177-3AD203B41FA5}">
                      <a16:colId xmlns:a16="http://schemas.microsoft.com/office/drawing/2014/main" val="2015736893"/>
                    </a:ext>
                  </a:extLst>
                </a:gridCol>
                <a:gridCol w="574847">
                  <a:extLst>
                    <a:ext uri="{9D8B030D-6E8A-4147-A177-3AD203B41FA5}">
                      <a16:colId xmlns:a16="http://schemas.microsoft.com/office/drawing/2014/main" val="4141925827"/>
                    </a:ext>
                  </a:extLst>
                </a:gridCol>
                <a:gridCol w="574847">
                  <a:extLst>
                    <a:ext uri="{9D8B030D-6E8A-4147-A177-3AD203B41FA5}">
                      <a16:colId xmlns:a16="http://schemas.microsoft.com/office/drawing/2014/main" val="2618087351"/>
                    </a:ext>
                  </a:extLst>
                </a:gridCol>
                <a:gridCol w="426742">
                  <a:extLst>
                    <a:ext uri="{9D8B030D-6E8A-4147-A177-3AD203B41FA5}">
                      <a16:colId xmlns:a16="http://schemas.microsoft.com/office/drawing/2014/main" val="3638728861"/>
                    </a:ext>
                  </a:extLst>
                </a:gridCol>
                <a:gridCol w="427245">
                  <a:extLst>
                    <a:ext uri="{9D8B030D-6E8A-4147-A177-3AD203B41FA5}">
                      <a16:colId xmlns:a16="http://schemas.microsoft.com/office/drawing/2014/main" val="4097623002"/>
                    </a:ext>
                  </a:extLst>
                </a:gridCol>
                <a:gridCol w="427245">
                  <a:extLst>
                    <a:ext uri="{9D8B030D-6E8A-4147-A177-3AD203B41FA5}">
                      <a16:colId xmlns:a16="http://schemas.microsoft.com/office/drawing/2014/main" val="2466099749"/>
                    </a:ext>
                  </a:extLst>
                </a:gridCol>
                <a:gridCol w="427245">
                  <a:extLst>
                    <a:ext uri="{9D8B030D-6E8A-4147-A177-3AD203B41FA5}">
                      <a16:colId xmlns:a16="http://schemas.microsoft.com/office/drawing/2014/main" val="3731624687"/>
                    </a:ext>
                  </a:extLst>
                </a:gridCol>
                <a:gridCol w="427245">
                  <a:extLst>
                    <a:ext uri="{9D8B030D-6E8A-4147-A177-3AD203B41FA5}">
                      <a16:colId xmlns:a16="http://schemas.microsoft.com/office/drawing/2014/main" val="3570952830"/>
                    </a:ext>
                  </a:extLst>
                </a:gridCol>
                <a:gridCol w="427245">
                  <a:extLst>
                    <a:ext uri="{9D8B030D-6E8A-4147-A177-3AD203B41FA5}">
                      <a16:colId xmlns:a16="http://schemas.microsoft.com/office/drawing/2014/main" val="870896201"/>
                    </a:ext>
                  </a:extLst>
                </a:gridCol>
                <a:gridCol w="427245">
                  <a:extLst>
                    <a:ext uri="{9D8B030D-6E8A-4147-A177-3AD203B41FA5}">
                      <a16:colId xmlns:a16="http://schemas.microsoft.com/office/drawing/2014/main" val="3991902877"/>
                    </a:ext>
                  </a:extLst>
                </a:gridCol>
              </a:tblGrid>
              <a:tr h="221587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tient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l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ays post implant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plantation/complication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P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ukocyte count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DG PET/CT visual interpretation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Vmax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B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2758562"/>
                  </a:ext>
                </a:extLst>
              </a:tr>
              <a:tr h="21881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cation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ndard</a:t>
                      </a:r>
                      <a:endParaRPr lang="en-GB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at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ndard</a:t>
                      </a:r>
                      <a:endParaRPr lang="en-GB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at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ndard</a:t>
                      </a:r>
                      <a:endParaRPr lang="en-GB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at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2703690"/>
                  </a:ext>
                </a:extLst>
              </a:tr>
              <a:tr h="2716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chan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9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complicated implantat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lse positiv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3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9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5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2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6932477"/>
                  </a:ext>
                </a:extLst>
              </a:tr>
              <a:tr h="43763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chan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ith Bentall-graft. Postoperative haematoma requiring re-thoracotomy and re-suturing of the graft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lse positiv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lse positiv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3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3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9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6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645987"/>
                  </a:ext>
                </a:extLst>
              </a:tr>
              <a:tr h="2716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chan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4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complicated implantat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lse positiv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3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2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7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3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5055845"/>
                  </a:ext>
                </a:extLst>
              </a:tr>
              <a:tr h="2716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og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complicated implantat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6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3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1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6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7791470"/>
                  </a:ext>
                </a:extLst>
              </a:tr>
              <a:tr h="21881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chan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2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toperative pneumothorax. No complications of the valve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3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2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7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3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4037525"/>
                  </a:ext>
                </a:extLst>
              </a:tr>
              <a:tr h="21881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og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complicated implantation. CABG in same sess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lse positiv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0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7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3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4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6590880"/>
                  </a:ext>
                </a:extLst>
              </a:tr>
              <a:tr h="2716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og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complicated implantat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lse positiv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3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6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9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2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0588285"/>
                  </a:ext>
                </a:extLst>
              </a:tr>
              <a:tr h="2716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chan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9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complicated implantat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nega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5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1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2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9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7252679"/>
                  </a:ext>
                </a:extLst>
              </a:tr>
              <a:tr h="21881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og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6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ith Bentall-graft. Uncomplicated implantat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8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7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4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9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1971655"/>
                  </a:ext>
                </a:extLst>
              </a:tr>
              <a:tr h="36220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og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toperative pneumothorax. No complications of the valve. CABG in same sess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2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5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2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6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2269235"/>
                  </a:ext>
                </a:extLst>
              </a:tr>
              <a:tr h="21881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og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complicated implantation. CABG in same sess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2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1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7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1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4073844"/>
                  </a:ext>
                </a:extLst>
              </a:tr>
              <a:tr h="2716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og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0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complicated implantat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.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9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8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0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2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9812741"/>
                  </a:ext>
                </a:extLst>
              </a:tr>
              <a:tr h="271657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ogic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6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complicated implantation.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1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9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0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.4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391431"/>
                  </a:ext>
                </a:extLst>
              </a:tr>
              <a:tr h="27165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1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lse negativ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ue positiv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2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4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4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66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527" marR="575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44240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1389" y="1488649"/>
            <a:ext cx="6597211" cy="3951713"/>
          </a:xfrm>
          <a:prstGeom prst="rect">
            <a:avLst/>
          </a:prstGeom>
        </p:spPr>
      </p:pic>
      <p:sp>
        <p:nvSpPr>
          <p:cNvPr id="6" name="Tijdelijke aanduiding voor inhoud 5"/>
          <p:cNvSpPr>
            <a:spLocks noGrp="1"/>
          </p:cNvSpPr>
          <p:nvPr>
            <p:ph idx="1"/>
          </p:nvPr>
        </p:nvSpPr>
        <p:spPr>
          <a:xfrm>
            <a:off x="838200" y="5486400"/>
            <a:ext cx="7391400" cy="411163"/>
          </a:xfrm>
        </p:spPr>
        <p:txBody>
          <a:bodyPr/>
          <a:lstStyle/>
          <a:p>
            <a:pPr marL="0" indent="0">
              <a:buNone/>
            </a:pPr>
            <a:r>
              <a:rPr lang="en-GB" sz="1000" dirty="0"/>
              <a:t>The spread of values for standard </a:t>
            </a:r>
            <a:r>
              <a:rPr lang="en-GB" sz="1000" dirty="0" err="1"/>
              <a:t>SUVmax</a:t>
            </a:r>
            <a:r>
              <a:rPr lang="en-GB" sz="1000" dirty="0"/>
              <a:t> (A), late </a:t>
            </a:r>
            <a:r>
              <a:rPr lang="en-GB" sz="1000" dirty="0" err="1"/>
              <a:t>SUVmax</a:t>
            </a:r>
            <a:r>
              <a:rPr lang="en-GB" sz="1000" dirty="0"/>
              <a:t> (B), changes in </a:t>
            </a:r>
            <a:r>
              <a:rPr lang="en-GB" sz="1000" dirty="0" err="1"/>
              <a:t>SUVmax</a:t>
            </a:r>
            <a:r>
              <a:rPr lang="en-GB" sz="1000" dirty="0"/>
              <a:t> from standard to late (</a:t>
            </a:r>
            <a:r>
              <a:rPr lang="en-GB" sz="1000" dirty="0" err="1"/>
              <a:t>ΔSUVmax</a:t>
            </a:r>
            <a:r>
              <a:rPr lang="en-GB" sz="1000" dirty="0"/>
              <a:t>, C) as well as standard and late Target-to-background ratios (TBR) and changes in TBR (D,E and F respectively). *: Statistical outlier.</a:t>
            </a:r>
          </a:p>
          <a:p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81000" y="2286001"/>
            <a:ext cx="8458200" cy="16002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GB" dirty="0"/>
              <a:t>Delayed imaging does not seem to improve the interpretation of FDG PET/CT in PVE as it seems prone to false positive findings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</TotalTime>
  <Words>638</Words>
  <Application>Microsoft Office PowerPoint</Application>
  <PresentationFormat>Diavoorstelling (4:3)</PresentationFormat>
  <Paragraphs>263</Paragraphs>
  <Slides>6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7</vt:i4>
      </vt:variant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16" baseType="lpstr">
      <vt:lpstr>MS PGothic</vt:lpstr>
      <vt:lpstr>Arial</vt:lpstr>
      <vt:lpstr>Arial Narrow</vt:lpstr>
      <vt:lpstr>Calibri</vt:lpstr>
      <vt:lpstr>Cambria</vt:lpstr>
      <vt:lpstr>SsykbnAdvPTimes</vt:lpstr>
      <vt:lpstr>Times New Roman</vt:lpstr>
      <vt:lpstr>2_Office Theme</vt:lpstr>
      <vt:lpstr>Custom Design</vt:lpstr>
      <vt:lpstr>1_Custom Design</vt:lpstr>
      <vt:lpstr>Dual time point FDG PET/CT imaging in prosthetic heart valve endocarditis</vt:lpstr>
      <vt:lpstr>BACKGROUND</vt:lpstr>
      <vt:lpstr>METHODS</vt:lpstr>
      <vt:lpstr>RESULTS</vt:lpstr>
      <vt:lpstr>RESULTS</vt:lpstr>
      <vt:lpstr>CONCLUS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sbjørn Scholtens</cp:lastModifiedBy>
  <cp:revision>104</cp:revision>
  <dcterms:created xsi:type="dcterms:W3CDTF">2011-04-18T21:44:13Z</dcterms:created>
  <dcterms:modified xsi:type="dcterms:W3CDTF">2017-04-10T17:28:14Z</dcterms:modified>
</cp:coreProperties>
</file>